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9" autoAdjust="0"/>
    <p:restoredTop sz="94660"/>
  </p:normalViewPr>
  <p:slideViewPr>
    <p:cSldViewPr snapToGrid="0">
      <p:cViewPr varScale="1">
        <p:scale>
          <a:sx n="67" d="100"/>
          <a:sy n="67" d="100"/>
        </p:scale>
        <p:origin x="17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999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4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14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26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5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03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8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46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7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0874997-6D95-424F-AC45-8CB75B5D63B2}"/>
              </a:ext>
            </a:extLst>
          </p:cNvPr>
          <p:cNvSpPr/>
          <p:nvPr/>
        </p:nvSpPr>
        <p:spPr>
          <a:xfrm>
            <a:off x="205740" y="8085322"/>
            <a:ext cx="63093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 S2. Histological images of the lungs during 16 weeks of infection in C57BL/6 mice by hematoxylin-eosin staining. Bars indicate 100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F75ABD93-590B-4FDD-A59E-8256FE5A17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4789" y="0"/>
            <a:ext cx="5511262" cy="79498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5308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7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eishi</dc:creator>
  <cp:lastModifiedBy>Tateishi</cp:lastModifiedBy>
  <cp:revision>3</cp:revision>
  <dcterms:created xsi:type="dcterms:W3CDTF">2022-12-07T03:50:42Z</dcterms:created>
  <dcterms:modified xsi:type="dcterms:W3CDTF">2022-12-07T03:59:21Z</dcterms:modified>
</cp:coreProperties>
</file>